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7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69C7853C-536D-4A76-A0AE-DD22124D55A5}" styleName="テーマ スタイル 1 - アクセント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9917"/>
    <p:restoredTop sz="94659"/>
  </p:normalViewPr>
  <p:slideViewPr>
    <p:cSldViewPr snapToGrid="0">
      <p:cViewPr varScale="1">
        <p:scale>
          <a:sx n="105" d="100"/>
          <a:sy n="105" d="100"/>
        </p:scale>
        <p:origin x="2488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E08530-7ECA-FF47-BD8B-0F5C484E2B75}" type="datetimeFigureOut">
              <a:rPr kumimoji="1" lang="ja-JP" altLang="en-US" smtClean="0"/>
              <a:t>2023/5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C7412-9F9D-024B-9CA1-05C64985E5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28153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E08530-7ECA-FF47-BD8B-0F5C484E2B75}" type="datetimeFigureOut">
              <a:rPr kumimoji="1" lang="ja-JP" altLang="en-US" smtClean="0"/>
              <a:t>2023/5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C7412-9F9D-024B-9CA1-05C64985E5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83249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E08530-7ECA-FF47-BD8B-0F5C484E2B75}" type="datetimeFigureOut">
              <a:rPr kumimoji="1" lang="ja-JP" altLang="en-US" smtClean="0"/>
              <a:t>2023/5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C7412-9F9D-024B-9CA1-05C64985E5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84443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E08530-7ECA-FF47-BD8B-0F5C484E2B75}" type="datetimeFigureOut">
              <a:rPr kumimoji="1" lang="ja-JP" altLang="en-US" smtClean="0"/>
              <a:t>2023/5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C7412-9F9D-024B-9CA1-05C64985E5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59651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E08530-7ECA-FF47-BD8B-0F5C484E2B75}" type="datetimeFigureOut">
              <a:rPr kumimoji="1" lang="ja-JP" altLang="en-US" smtClean="0"/>
              <a:t>2023/5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C7412-9F9D-024B-9CA1-05C64985E5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14712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E08530-7ECA-FF47-BD8B-0F5C484E2B75}" type="datetimeFigureOut">
              <a:rPr kumimoji="1" lang="ja-JP" altLang="en-US" smtClean="0"/>
              <a:t>2023/5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C7412-9F9D-024B-9CA1-05C64985E5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59193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E08530-7ECA-FF47-BD8B-0F5C484E2B75}" type="datetimeFigureOut">
              <a:rPr kumimoji="1" lang="ja-JP" altLang="en-US" smtClean="0"/>
              <a:t>2023/5/3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C7412-9F9D-024B-9CA1-05C64985E5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68903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E08530-7ECA-FF47-BD8B-0F5C484E2B75}" type="datetimeFigureOut">
              <a:rPr kumimoji="1" lang="ja-JP" altLang="en-US" smtClean="0"/>
              <a:t>2023/5/3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C7412-9F9D-024B-9CA1-05C64985E5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846880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E08530-7ECA-FF47-BD8B-0F5C484E2B75}" type="datetimeFigureOut">
              <a:rPr kumimoji="1" lang="ja-JP" altLang="en-US" smtClean="0"/>
              <a:t>2023/5/3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C7412-9F9D-024B-9CA1-05C64985E5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35715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E08530-7ECA-FF47-BD8B-0F5C484E2B75}" type="datetimeFigureOut">
              <a:rPr kumimoji="1" lang="ja-JP" altLang="en-US" smtClean="0"/>
              <a:t>2023/5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C7412-9F9D-024B-9CA1-05C64985E5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49545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E08530-7ECA-FF47-BD8B-0F5C484E2B75}" type="datetimeFigureOut">
              <a:rPr kumimoji="1" lang="ja-JP" altLang="en-US" smtClean="0"/>
              <a:t>2023/5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C7412-9F9D-024B-9CA1-05C64985E5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47049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E08530-7ECA-FF47-BD8B-0F5C484E2B75}" type="datetimeFigureOut">
              <a:rPr kumimoji="1" lang="ja-JP" altLang="en-US" smtClean="0"/>
              <a:t>2023/5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5C7412-9F9D-024B-9CA1-05C64985E5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3609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6C13A2C0-021B-D4DA-8C81-88B6D4885C4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00277598"/>
              </p:ext>
            </p:extLst>
          </p:nvPr>
        </p:nvGraphicFramePr>
        <p:xfrm>
          <a:off x="67729" y="448282"/>
          <a:ext cx="9759100" cy="2741295"/>
        </p:xfrm>
        <a:graphic>
          <a:graphicData uri="http://schemas.openxmlformats.org/drawingml/2006/table">
            <a:tbl>
              <a:tblPr/>
              <a:tblGrid>
                <a:gridCol w="371540">
                  <a:extLst>
                    <a:ext uri="{9D8B030D-6E8A-4147-A177-3AD203B41FA5}">
                      <a16:colId xmlns:a16="http://schemas.microsoft.com/office/drawing/2014/main" val="1402894734"/>
                    </a:ext>
                  </a:extLst>
                </a:gridCol>
                <a:gridCol w="682909">
                  <a:extLst>
                    <a:ext uri="{9D8B030D-6E8A-4147-A177-3AD203B41FA5}">
                      <a16:colId xmlns:a16="http://schemas.microsoft.com/office/drawing/2014/main" val="4242484255"/>
                    </a:ext>
                  </a:extLst>
                </a:gridCol>
                <a:gridCol w="359426">
                  <a:extLst>
                    <a:ext uri="{9D8B030D-6E8A-4147-A177-3AD203B41FA5}">
                      <a16:colId xmlns:a16="http://schemas.microsoft.com/office/drawing/2014/main" val="1179551053"/>
                    </a:ext>
                  </a:extLst>
                </a:gridCol>
                <a:gridCol w="287541">
                  <a:extLst>
                    <a:ext uri="{9D8B030D-6E8A-4147-A177-3AD203B41FA5}">
                      <a16:colId xmlns:a16="http://schemas.microsoft.com/office/drawing/2014/main" val="507853246"/>
                    </a:ext>
                  </a:extLst>
                </a:gridCol>
                <a:gridCol w="433436">
                  <a:extLst>
                    <a:ext uri="{9D8B030D-6E8A-4147-A177-3AD203B41FA5}">
                      <a16:colId xmlns:a16="http://schemas.microsoft.com/office/drawing/2014/main" val="4223566442"/>
                    </a:ext>
                  </a:extLst>
                </a:gridCol>
                <a:gridCol w="431311">
                  <a:extLst>
                    <a:ext uri="{9D8B030D-6E8A-4147-A177-3AD203B41FA5}">
                      <a16:colId xmlns:a16="http://schemas.microsoft.com/office/drawing/2014/main" val="1501797806"/>
                    </a:ext>
                  </a:extLst>
                </a:gridCol>
                <a:gridCol w="864000">
                  <a:extLst>
                    <a:ext uri="{9D8B030D-6E8A-4147-A177-3AD203B41FA5}">
                      <a16:colId xmlns:a16="http://schemas.microsoft.com/office/drawing/2014/main" val="4147355019"/>
                    </a:ext>
                  </a:extLst>
                </a:gridCol>
                <a:gridCol w="503196">
                  <a:extLst>
                    <a:ext uri="{9D8B030D-6E8A-4147-A177-3AD203B41FA5}">
                      <a16:colId xmlns:a16="http://schemas.microsoft.com/office/drawing/2014/main" val="2527622593"/>
                    </a:ext>
                  </a:extLst>
                </a:gridCol>
                <a:gridCol w="395369">
                  <a:extLst>
                    <a:ext uri="{9D8B030D-6E8A-4147-A177-3AD203B41FA5}">
                      <a16:colId xmlns:a16="http://schemas.microsoft.com/office/drawing/2014/main" val="1123419983"/>
                    </a:ext>
                  </a:extLst>
                </a:gridCol>
                <a:gridCol w="588814">
                  <a:extLst>
                    <a:ext uri="{9D8B030D-6E8A-4147-A177-3AD203B41FA5}">
                      <a16:colId xmlns:a16="http://schemas.microsoft.com/office/drawing/2014/main" val="559961964"/>
                    </a:ext>
                  </a:extLst>
                </a:gridCol>
                <a:gridCol w="790737">
                  <a:extLst>
                    <a:ext uri="{9D8B030D-6E8A-4147-A177-3AD203B41FA5}">
                      <a16:colId xmlns:a16="http://schemas.microsoft.com/office/drawing/2014/main" val="2627869508"/>
                    </a:ext>
                  </a:extLst>
                </a:gridCol>
                <a:gridCol w="706610">
                  <a:extLst>
                    <a:ext uri="{9D8B030D-6E8A-4147-A177-3AD203B41FA5}">
                      <a16:colId xmlns:a16="http://schemas.microsoft.com/office/drawing/2014/main" val="3885790698"/>
                    </a:ext>
                  </a:extLst>
                </a:gridCol>
                <a:gridCol w="826680">
                  <a:extLst>
                    <a:ext uri="{9D8B030D-6E8A-4147-A177-3AD203B41FA5}">
                      <a16:colId xmlns:a16="http://schemas.microsoft.com/office/drawing/2014/main" val="413858037"/>
                    </a:ext>
                  </a:extLst>
                </a:gridCol>
                <a:gridCol w="682909">
                  <a:extLst>
                    <a:ext uri="{9D8B030D-6E8A-4147-A177-3AD203B41FA5}">
                      <a16:colId xmlns:a16="http://schemas.microsoft.com/office/drawing/2014/main" val="13064296"/>
                    </a:ext>
                  </a:extLst>
                </a:gridCol>
                <a:gridCol w="862622">
                  <a:extLst>
                    <a:ext uri="{9D8B030D-6E8A-4147-A177-3AD203B41FA5}">
                      <a16:colId xmlns:a16="http://schemas.microsoft.com/office/drawing/2014/main" val="759699440"/>
                    </a:ext>
                  </a:extLst>
                </a:gridCol>
                <a:gridCol w="972000">
                  <a:extLst>
                    <a:ext uri="{9D8B030D-6E8A-4147-A177-3AD203B41FA5}">
                      <a16:colId xmlns:a16="http://schemas.microsoft.com/office/drawing/2014/main" val="1204453143"/>
                    </a:ext>
                  </a:extLst>
                </a:gridCol>
              </a:tblGrid>
              <a:tr h="26608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Ag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Vaccine statu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Diseas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Sex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HSC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Sourc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Days between HSCT and Tix/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Cil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Rituximab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CAR-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Histrory of COVID-1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Days between previous COVID-19 and Tix/Cil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Days between Tix/Cil and COVID-1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Treatmen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Hospitalizatio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Death due to COVID-1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Severity of COVID-1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73123304"/>
                  </a:ext>
                </a:extLst>
              </a:tr>
              <a:tr h="910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2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Unvaccinate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Other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F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+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CB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1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9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RDV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+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Mil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92835223"/>
                  </a:ext>
                </a:extLst>
              </a:tr>
              <a:tr h="6162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2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Unvaccinate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ALL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M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+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rPBSC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-16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RDV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+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Mil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29528996"/>
                  </a:ext>
                </a:extLst>
              </a:tr>
              <a:tr h="910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3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3 or more dose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HL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F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+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uBM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-329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1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MOL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Mil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96882553"/>
                  </a:ext>
                </a:extLst>
              </a:tr>
              <a:tr h="6162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3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3 or more dose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MD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F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+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CB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N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N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Mil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2311699"/>
                  </a:ext>
                </a:extLst>
              </a:tr>
              <a:tr h="910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4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Unvaccinate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Other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F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+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CB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-18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1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No medicatio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Asymptomatic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60600169"/>
                  </a:ext>
                </a:extLst>
              </a:tr>
              <a:tr h="6162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5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3 or more dose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Other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F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7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RDV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+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Mil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96564602"/>
                  </a:ext>
                </a:extLst>
              </a:tr>
              <a:tr h="6162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5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2 dose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MD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M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+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CB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-17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5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RDV, BAR, DEX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+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Sever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21368193"/>
                  </a:ext>
                </a:extLst>
              </a:tr>
              <a:tr h="910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5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3 or more dose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NHL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F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+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N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N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Mil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0947208"/>
                  </a:ext>
                </a:extLst>
              </a:tr>
              <a:tr h="6162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5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2 dose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NHL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M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+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+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1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1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NIR/RI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+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Moderat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83627648"/>
                  </a:ext>
                </a:extLst>
              </a:tr>
              <a:tr h="6162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6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Unknow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MD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F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+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uPBSC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-52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3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N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Mil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06757881"/>
                  </a:ext>
                </a:extLst>
              </a:tr>
              <a:tr h="6162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6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Unvaccinate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ALL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F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+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CB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-67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2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RDV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+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Mil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219274"/>
                  </a:ext>
                </a:extLst>
              </a:tr>
              <a:tr h="910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6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2 dose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NHL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M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+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+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3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NIR/RI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Mil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59199832"/>
                  </a:ext>
                </a:extLst>
              </a:tr>
              <a:tr h="6162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6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1 dos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AML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M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+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CB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-43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3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RDV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+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Moderat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3954630"/>
                  </a:ext>
                </a:extLst>
              </a:tr>
              <a:tr h="910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7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3 or more dose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Other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M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3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RDV, DEX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+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Sever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4389734"/>
                  </a:ext>
                </a:extLst>
              </a:tr>
              <a:tr h="910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7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3 or more dose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AML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M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+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rPBSC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-364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MOL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+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Mil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3889735"/>
                  </a:ext>
                </a:extLst>
              </a:tr>
              <a:tr h="910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7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Unknow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MM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F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1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DEX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+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Sever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13633127"/>
                  </a:ext>
                </a:extLst>
              </a:tr>
              <a:tr h="910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8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3 or more dose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CLL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F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+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1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MOL, RDV, DEX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+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Sever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91280044"/>
                  </a:ext>
                </a:extLst>
              </a:tr>
              <a:tr h="910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8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3 or more dose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NHL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M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+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RDV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+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–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Mil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39049428"/>
                  </a:ext>
                </a:extLst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138A0B30-C745-AB88-3BD6-551717AE34AC}"/>
              </a:ext>
            </a:extLst>
          </p:cNvPr>
          <p:cNvSpPr txBox="1"/>
          <p:nvPr/>
        </p:nvSpPr>
        <p:spPr>
          <a:xfrm>
            <a:off x="-8473" y="0"/>
            <a:ext cx="4841390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table</a:t>
            </a:r>
          </a:p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racteristics of the patients who developed COVID-19 after Tix/</a:t>
            </a:r>
            <a:r>
              <a:rPr kumimoji="1" lang="en-US" altLang="ja-JP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l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dministration. </a:t>
            </a:r>
            <a:endParaRPr kumimoji="1" lang="ja-JP" altLang="en-US" sz="10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7D8DA198-61A5-0257-74AA-EFD905B1B5B8}"/>
              </a:ext>
            </a:extLst>
          </p:cNvPr>
          <p:cNvSpPr txBox="1"/>
          <p:nvPr/>
        </p:nvSpPr>
        <p:spPr>
          <a:xfrm>
            <a:off x="67729" y="3226153"/>
            <a:ext cx="9717972" cy="9002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breviations: AML, acute myeloid leukemia; MDS, myelodysplastic syndromes; CML, chronic myeloid leukemia; ALL, acute lymphocytic leukemia; CLL, chronic lymphocytic leukemia; HL, Hodgkin lymphoma, NHL, non Hodgkin lymphoma; MM, multiple myeloma; HSCT, hematological stem cell transplantation; CBT, cord blood transplantation; </a:t>
            </a:r>
            <a:r>
              <a:rPr kumimoji="1" lang="en-US" altLang="ja-JP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PBSCT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elated peripheral blood stem cell transplantation; </a:t>
            </a:r>
            <a:r>
              <a:rPr kumimoji="1" lang="en-US" altLang="ja-JP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PBSCT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unrelated peripheral blood stem cell transplantation; </a:t>
            </a:r>
            <a:r>
              <a:rPr kumimoji="1" lang="en-US" altLang="ja-JP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BMT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unrelated bone marrow transplantation; CAR-T, chimeric antigen receptor-T; NIR/RIT, </a:t>
            </a:r>
            <a:r>
              <a:rPr kumimoji="1" lang="en-US" altLang="ja-JP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irmatrelvir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ritonavir; RDV, remdesivir; MOL, </a:t>
            </a:r>
            <a:r>
              <a:rPr kumimoji="1" lang="en-US" altLang="ja-JP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lnupiravir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DEX, dexamethasone; BAR, </a:t>
            </a:r>
            <a:r>
              <a:rPr kumimoji="1" lang="en-US" altLang="ja-JP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ricitinib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Tix/</a:t>
            </a:r>
            <a:r>
              <a:rPr kumimoji="1" lang="en-US" altLang="ja-JP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l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kumimoji="1" lang="en-US" altLang="ja-JP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ixagevimab-cilgavimab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NA, not available.</a:t>
            </a:r>
            <a:endParaRPr kumimoji="1" lang="ja-JP" altLang="en-US" sz="10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851853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638</TotalTime>
  <Words>523</Words>
  <Application>Microsoft Macintosh PowerPoint</Application>
  <PresentationFormat>A4 210 x 297 mm</PresentationFormat>
  <Paragraphs>30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瑞樹 原口</dc:creator>
  <cp:lastModifiedBy>瑞樹 原口</cp:lastModifiedBy>
  <cp:revision>20</cp:revision>
  <cp:lastPrinted>2023-03-16T09:13:35Z</cp:lastPrinted>
  <dcterms:created xsi:type="dcterms:W3CDTF">2023-03-16T01:38:46Z</dcterms:created>
  <dcterms:modified xsi:type="dcterms:W3CDTF">2023-05-31T03:41:56Z</dcterms:modified>
</cp:coreProperties>
</file>